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944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4393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8095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7359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5509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1224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084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9252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2012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22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123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64DC2-C490-4A96-AC70-1D376897C125}" type="datetimeFigureOut">
              <a:rPr lang="fr-FR" smtClean="0"/>
              <a:t>0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AB3627-5503-4F5B-B247-2C2811F1604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3618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/>
          <p:cNvGrpSpPr/>
          <p:nvPr/>
        </p:nvGrpSpPr>
        <p:grpSpPr>
          <a:xfrm>
            <a:off x="3556671" y="5343749"/>
            <a:ext cx="1234710" cy="307777"/>
            <a:chOff x="2348880" y="3995936"/>
            <a:chExt cx="1234710" cy="307777"/>
          </a:xfrm>
        </p:grpSpPr>
        <p:sp>
          <p:nvSpPr>
            <p:cNvPr id="12" name="ZoneTexte 11"/>
            <p:cNvSpPr txBox="1"/>
            <p:nvPr/>
          </p:nvSpPr>
          <p:spPr>
            <a:xfrm>
              <a:off x="2348880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2h</a:t>
              </a:r>
              <a:endParaRPr lang="fr-FR" sz="1400" dirty="0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2780928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4h</a:t>
              </a:r>
              <a:endParaRPr lang="fr-FR" sz="1400" dirty="0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3212976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8h</a:t>
              </a:r>
              <a:endParaRPr lang="fr-FR" sz="1400" dirty="0"/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5140847" y="5343749"/>
            <a:ext cx="1234710" cy="307777"/>
            <a:chOff x="2348880" y="3995936"/>
            <a:chExt cx="1234710" cy="307777"/>
          </a:xfrm>
        </p:grpSpPr>
        <p:sp>
          <p:nvSpPr>
            <p:cNvPr id="9" name="ZoneTexte 8"/>
            <p:cNvSpPr txBox="1"/>
            <p:nvPr/>
          </p:nvSpPr>
          <p:spPr>
            <a:xfrm>
              <a:off x="2348880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2h</a:t>
              </a:r>
              <a:endParaRPr lang="fr-FR" sz="1400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780928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4h</a:t>
              </a:r>
              <a:endParaRPr lang="fr-FR" sz="1400" dirty="0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3212976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8h</a:t>
              </a:r>
              <a:endParaRPr lang="fr-FR" sz="1400" dirty="0"/>
            </a:p>
          </p:txBody>
        </p:sp>
      </p:grpSp>
      <p:sp>
        <p:nvSpPr>
          <p:cNvPr id="8" name="ZoneTexte 7"/>
          <p:cNvSpPr txBox="1"/>
          <p:nvPr/>
        </p:nvSpPr>
        <p:spPr>
          <a:xfrm>
            <a:off x="4564783" y="3111501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27L</a:t>
            </a:r>
            <a:endParaRPr lang="fr-FR" dirty="0"/>
          </a:p>
        </p:txBody>
      </p:sp>
      <p:grpSp>
        <p:nvGrpSpPr>
          <p:cNvPr id="17" name="Groupe 16"/>
          <p:cNvGrpSpPr/>
          <p:nvPr/>
        </p:nvGrpSpPr>
        <p:grpSpPr>
          <a:xfrm>
            <a:off x="3613226" y="2680844"/>
            <a:ext cx="1234710" cy="307777"/>
            <a:chOff x="2348880" y="3995936"/>
            <a:chExt cx="1234710" cy="307777"/>
          </a:xfrm>
        </p:grpSpPr>
        <p:sp>
          <p:nvSpPr>
            <p:cNvPr id="23" name="ZoneTexte 22"/>
            <p:cNvSpPr txBox="1"/>
            <p:nvPr/>
          </p:nvSpPr>
          <p:spPr>
            <a:xfrm>
              <a:off x="2348880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2h</a:t>
              </a:r>
              <a:endParaRPr lang="fr-FR" sz="1400" dirty="0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2780928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4h</a:t>
              </a:r>
              <a:endParaRPr lang="fr-FR" sz="1400" dirty="0"/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3212976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8h</a:t>
              </a:r>
              <a:endParaRPr lang="fr-FR" sz="1400" dirty="0"/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5197402" y="2680844"/>
            <a:ext cx="1234710" cy="307777"/>
            <a:chOff x="2348880" y="3995936"/>
            <a:chExt cx="1234710" cy="307777"/>
          </a:xfrm>
        </p:grpSpPr>
        <p:sp>
          <p:nvSpPr>
            <p:cNvPr id="20" name="ZoneTexte 19"/>
            <p:cNvSpPr txBox="1"/>
            <p:nvPr/>
          </p:nvSpPr>
          <p:spPr>
            <a:xfrm>
              <a:off x="2348880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2h</a:t>
              </a:r>
              <a:endParaRPr lang="fr-FR" sz="1400" dirty="0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2780928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4h</a:t>
              </a:r>
              <a:endParaRPr lang="fr-FR" sz="1400" dirty="0"/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3212976" y="3995936"/>
              <a:ext cx="37061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/>
                <a:t>8h</a:t>
              </a:r>
              <a:endParaRPr lang="fr-FR" sz="1400" dirty="0"/>
            </a:p>
          </p:txBody>
        </p:sp>
      </p:grpSp>
      <p:sp>
        <p:nvSpPr>
          <p:cNvPr id="19" name="ZoneTexte 18"/>
          <p:cNvSpPr txBox="1"/>
          <p:nvPr/>
        </p:nvSpPr>
        <p:spPr>
          <a:xfrm>
            <a:off x="4837362" y="592612"/>
            <a:ext cx="51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9L</a:t>
            </a:r>
            <a:endParaRPr lang="fr-FR" dirty="0"/>
          </a:p>
        </p:txBody>
      </p:sp>
      <p:sp>
        <p:nvSpPr>
          <p:cNvPr id="2" name="ZoneTexte 1"/>
          <p:cNvSpPr txBox="1"/>
          <p:nvPr/>
        </p:nvSpPr>
        <p:spPr>
          <a:xfrm>
            <a:off x="7418566" y="961944"/>
            <a:ext cx="4214191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fr-FR" sz="1600" b="1" smtClean="0">
                <a:latin typeface="Arial" panose="020B0604020202020204" pitchFamily="34" charset="0"/>
                <a:cs typeface="Arial" panose="020B0604020202020204" pitchFamily="34" charset="0"/>
              </a:rPr>
              <a:t>Fig: </a:t>
            </a:r>
            <a:r>
              <a:rPr lang="fr-F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ial</a:t>
            </a:r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 of the E7L and </a:t>
            </a:r>
            <a:r>
              <a:rPr lang="fr-F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27L </a:t>
            </a:r>
            <a:r>
              <a:rPr lang="fr-F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a pair of non-TNBC and TNBC canine </a:t>
            </a:r>
            <a:r>
              <a:rPr lang="fr-F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on-TNBC (white bars) or TNBC (black bars)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at MOI of 0.1 and total RNA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cted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2, 4 and 8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post-infection. The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of expression of E9L and A27L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by quantitative RT-PCR and 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to the expression of beta-</a:t>
            </a:r>
            <a:r>
              <a:rPr lang="fr-F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fr-F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9703788"/>
              </p:ext>
            </p:extLst>
          </p:nvPr>
        </p:nvGraphicFramePr>
        <p:xfrm>
          <a:off x="3008863" y="3255420"/>
          <a:ext cx="3409950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3" imgW="3410640" imgH="2176200" progId="Prism5.Document">
                  <p:embed/>
                </p:oleObj>
              </mc:Choice>
              <mc:Fallback>
                <p:oleObj name="Prism 5" r:id="rId3" imgW="3410640" imgH="2176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008863" y="3255420"/>
                        <a:ext cx="3409950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7920198"/>
              </p:ext>
            </p:extLst>
          </p:nvPr>
        </p:nvGraphicFramePr>
        <p:xfrm>
          <a:off x="2953300" y="592612"/>
          <a:ext cx="3521075" cy="2176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5" imgW="3520440" imgH="2176200" progId="Prism5.Document">
                  <p:embed/>
                </p:oleObj>
              </mc:Choice>
              <mc:Fallback>
                <p:oleObj name="Prism 5" r:id="rId5" imgW="3520440" imgH="2176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53300" y="592612"/>
                        <a:ext cx="3521075" cy="2176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6965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89</Words>
  <Application>Microsoft Office PowerPoint</Application>
  <PresentationFormat>Grand écran</PresentationFormat>
  <Paragraphs>15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5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orges I</dc:creator>
  <cp:lastModifiedBy>Georges I</cp:lastModifiedBy>
  <cp:revision>11</cp:revision>
  <dcterms:created xsi:type="dcterms:W3CDTF">2018-02-12T11:40:41Z</dcterms:created>
  <dcterms:modified xsi:type="dcterms:W3CDTF">2020-10-01T13:24:30Z</dcterms:modified>
</cp:coreProperties>
</file>